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501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566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826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58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97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61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612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75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909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4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248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071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8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ctrTitle"/>
          </p:nvPr>
        </p:nvSpPr>
        <p:spPr>
          <a:xfrm>
            <a:off x="1524000" y="1491917"/>
            <a:ext cx="9144000" cy="1142148"/>
          </a:xfrm>
        </p:spPr>
        <p:txBody>
          <a:bodyPr>
            <a:norm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ph type="subTitle" idx="1"/>
          </p:nvPr>
        </p:nvSpPr>
        <p:spPr>
          <a:xfrm>
            <a:off x="1524000" y="3361407"/>
            <a:ext cx="9144000" cy="652328"/>
          </a:xfrm>
        </p:spPr>
        <p:txBody>
          <a:bodyPr/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aspase-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159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568918" y="3777990"/>
            <a:ext cx="978529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8.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spase-1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t 60 d,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2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d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ge in Figure 6. </a:t>
            </a:r>
            <a:r>
              <a:rPr lang="en-GB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cale bar = </a:t>
            </a:r>
            <a:r>
              <a:rPr lang="en-GB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GB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885" y="748444"/>
            <a:ext cx="10284925" cy="2788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6779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31</Words>
  <Application>Microsoft Office PowerPoint</Application>
  <PresentationFormat>宽屏</PresentationFormat>
  <Paragraphs>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Additional file 6 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yunzh</dc:creator>
  <cp:lastModifiedBy>haoyunzh</cp:lastModifiedBy>
  <cp:revision>19</cp:revision>
  <dcterms:created xsi:type="dcterms:W3CDTF">2022-07-02T10:37:19Z</dcterms:created>
  <dcterms:modified xsi:type="dcterms:W3CDTF">2022-08-01T06:46:54Z</dcterms:modified>
</cp:coreProperties>
</file>